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135938" cy="115204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0" autoAdjust="0"/>
    <p:restoredTop sz="94660"/>
  </p:normalViewPr>
  <p:slideViewPr>
    <p:cSldViewPr snapToGrid="0">
      <p:cViewPr varScale="1">
        <p:scale>
          <a:sx n="57" d="100"/>
          <a:sy n="57" d="100"/>
        </p:scale>
        <p:origin x="2180" y="1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0196" y="1885414"/>
            <a:ext cx="6915547" cy="4010837"/>
          </a:xfrm>
        </p:spPr>
        <p:txBody>
          <a:bodyPr anchor="b"/>
          <a:lstStyle>
            <a:lvl1pPr algn="ctr">
              <a:defRPr sz="53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16992" y="6050924"/>
            <a:ext cx="6101954" cy="2781450"/>
          </a:xfrm>
        </p:spPr>
        <p:txBody>
          <a:bodyPr/>
          <a:lstStyle>
            <a:lvl1pPr marL="0" indent="0" algn="ctr">
              <a:buNone/>
              <a:defRPr sz="2136"/>
            </a:lvl1pPr>
            <a:lvl2pPr marL="406817" indent="0" algn="ctr">
              <a:buNone/>
              <a:defRPr sz="1780"/>
            </a:lvl2pPr>
            <a:lvl3pPr marL="813633" indent="0" algn="ctr">
              <a:buNone/>
              <a:defRPr sz="1602"/>
            </a:lvl3pPr>
            <a:lvl4pPr marL="1220450" indent="0" algn="ctr">
              <a:buNone/>
              <a:defRPr sz="1424"/>
            </a:lvl4pPr>
            <a:lvl5pPr marL="1627266" indent="0" algn="ctr">
              <a:buNone/>
              <a:defRPr sz="1424"/>
            </a:lvl5pPr>
            <a:lvl6pPr marL="2034083" indent="0" algn="ctr">
              <a:buNone/>
              <a:defRPr sz="1424"/>
            </a:lvl6pPr>
            <a:lvl7pPr marL="2440899" indent="0" algn="ctr">
              <a:buNone/>
              <a:defRPr sz="1424"/>
            </a:lvl7pPr>
            <a:lvl8pPr marL="2847716" indent="0" algn="ctr">
              <a:buNone/>
              <a:defRPr sz="1424"/>
            </a:lvl8pPr>
            <a:lvl9pPr marL="3254532" indent="0" algn="ctr">
              <a:buNone/>
              <a:defRPr sz="1424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84296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023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22281" y="613359"/>
            <a:ext cx="1754312" cy="9763081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9346" y="613359"/>
            <a:ext cx="5161236" cy="9763081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527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496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55108" y="2872125"/>
            <a:ext cx="7017247" cy="4792202"/>
          </a:xfrm>
        </p:spPr>
        <p:txBody>
          <a:bodyPr anchor="b"/>
          <a:lstStyle>
            <a:lvl1pPr>
              <a:defRPr sz="53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5108" y="7709663"/>
            <a:ext cx="7017247" cy="2520106"/>
          </a:xfrm>
        </p:spPr>
        <p:txBody>
          <a:bodyPr/>
          <a:lstStyle>
            <a:lvl1pPr marL="0" indent="0">
              <a:buNone/>
              <a:defRPr sz="2136">
                <a:solidFill>
                  <a:schemeClr val="tx1"/>
                </a:solidFill>
              </a:defRPr>
            </a:lvl1pPr>
            <a:lvl2pPr marL="406817" indent="0">
              <a:buNone/>
              <a:defRPr sz="1780">
                <a:solidFill>
                  <a:schemeClr val="tx1">
                    <a:tint val="75000"/>
                  </a:schemeClr>
                </a:solidFill>
              </a:defRPr>
            </a:lvl2pPr>
            <a:lvl3pPr marL="813633" indent="0">
              <a:buNone/>
              <a:defRPr sz="1602">
                <a:solidFill>
                  <a:schemeClr val="tx1">
                    <a:tint val="75000"/>
                  </a:schemeClr>
                </a:solidFill>
              </a:defRPr>
            </a:lvl3pPr>
            <a:lvl4pPr marL="1220450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4pPr>
            <a:lvl5pPr marL="1627266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5pPr>
            <a:lvl6pPr marL="2034083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6pPr>
            <a:lvl7pPr marL="2440899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7pPr>
            <a:lvl8pPr marL="2847716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8pPr>
            <a:lvl9pPr marL="3254532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13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59346" y="3066796"/>
            <a:ext cx="3457774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18818" y="3066796"/>
            <a:ext cx="3457774" cy="730964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877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613362"/>
            <a:ext cx="7017247" cy="222676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0406" y="2824120"/>
            <a:ext cx="3441883" cy="1384058"/>
          </a:xfrm>
        </p:spPr>
        <p:txBody>
          <a:bodyPr anchor="b"/>
          <a:lstStyle>
            <a:lvl1pPr marL="0" indent="0">
              <a:buNone/>
              <a:defRPr sz="2136" b="1"/>
            </a:lvl1pPr>
            <a:lvl2pPr marL="406817" indent="0">
              <a:buNone/>
              <a:defRPr sz="1780" b="1"/>
            </a:lvl2pPr>
            <a:lvl3pPr marL="813633" indent="0">
              <a:buNone/>
              <a:defRPr sz="1602" b="1"/>
            </a:lvl3pPr>
            <a:lvl4pPr marL="1220450" indent="0">
              <a:buNone/>
              <a:defRPr sz="1424" b="1"/>
            </a:lvl4pPr>
            <a:lvl5pPr marL="1627266" indent="0">
              <a:buNone/>
              <a:defRPr sz="1424" b="1"/>
            </a:lvl5pPr>
            <a:lvl6pPr marL="2034083" indent="0">
              <a:buNone/>
              <a:defRPr sz="1424" b="1"/>
            </a:lvl6pPr>
            <a:lvl7pPr marL="2440899" indent="0">
              <a:buNone/>
              <a:defRPr sz="1424" b="1"/>
            </a:lvl7pPr>
            <a:lvl8pPr marL="2847716" indent="0">
              <a:buNone/>
              <a:defRPr sz="1424" b="1"/>
            </a:lvl8pPr>
            <a:lvl9pPr marL="3254532" indent="0">
              <a:buNone/>
              <a:defRPr sz="14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0406" y="4208178"/>
            <a:ext cx="3441883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18819" y="2824120"/>
            <a:ext cx="3458833" cy="1384058"/>
          </a:xfrm>
        </p:spPr>
        <p:txBody>
          <a:bodyPr anchor="b"/>
          <a:lstStyle>
            <a:lvl1pPr marL="0" indent="0">
              <a:buNone/>
              <a:defRPr sz="2136" b="1"/>
            </a:lvl1pPr>
            <a:lvl2pPr marL="406817" indent="0">
              <a:buNone/>
              <a:defRPr sz="1780" b="1"/>
            </a:lvl2pPr>
            <a:lvl3pPr marL="813633" indent="0">
              <a:buNone/>
              <a:defRPr sz="1602" b="1"/>
            </a:lvl3pPr>
            <a:lvl4pPr marL="1220450" indent="0">
              <a:buNone/>
              <a:defRPr sz="1424" b="1"/>
            </a:lvl4pPr>
            <a:lvl5pPr marL="1627266" indent="0">
              <a:buNone/>
              <a:defRPr sz="1424" b="1"/>
            </a:lvl5pPr>
            <a:lvl6pPr marL="2034083" indent="0">
              <a:buNone/>
              <a:defRPr sz="1424" b="1"/>
            </a:lvl6pPr>
            <a:lvl7pPr marL="2440899" indent="0">
              <a:buNone/>
              <a:defRPr sz="1424" b="1"/>
            </a:lvl7pPr>
            <a:lvl8pPr marL="2847716" indent="0">
              <a:buNone/>
              <a:defRPr sz="1424" b="1"/>
            </a:lvl8pPr>
            <a:lvl9pPr marL="3254532" indent="0">
              <a:buNone/>
              <a:defRPr sz="1424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18819" y="4208178"/>
            <a:ext cx="3458833" cy="618959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1788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6036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1184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768032"/>
            <a:ext cx="2624052" cy="2688114"/>
          </a:xfrm>
        </p:spPr>
        <p:txBody>
          <a:bodyPr anchor="b"/>
          <a:lstStyle>
            <a:lvl1pPr>
              <a:defRPr sz="2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58833" y="1658740"/>
            <a:ext cx="4118819" cy="8187013"/>
          </a:xfrm>
        </p:spPr>
        <p:txBody>
          <a:bodyPr/>
          <a:lstStyle>
            <a:lvl1pPr>
              <a:defRPr sz="2847"/>
            </a:lvl1pPr>
            <a:lvl2pPr>
              <a:defRPr sz="2491"/>
            </a:lvl2pPr>
            <a:lvl3pPr>
              <a:defRPr sz="2136"/>
            </a:lvl3pPr>
            <a:lvl4pPr>
              <a:defRPr sz="1780"/>
            </a:lvl4pPr>
            <a:lvl5pPr>
              <a:defRPr sz="1780"/>
            </a:lvl5pPr>
            <a:lvl6pPr>
              <a:defRPr sz="1780"/>
            </a:lvl6pPr>
            <a:lvl7pPr>
              <a:defRPr sz="1780"/>
            </a:lvl7pPr>
            <a:lvl8pPr>
              <a:defRPr sz="1780"/>
            </a:lvl8pPr>
            <a:lvl9pPr>
              <a:defRPr sz="178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0405" y="3456146"/>
            <a:ext cx="2624052" cy="6402939"/>
          </a:xfrm>
        </p:spPr>
        <p:txBody>
          <a:bodyPr/>
          <a:lstStyle>
            <a:lvl1pPr marL="0" indent="0">
              <a:buNone/>
              <a:defRPr sz="1424"/>
            </a:lvl1pPr>
            <a:lvl2pPr marL="406817" indent="0">
              <a:buNone/>
              <a:defRPr sz="1246"/>
            </a:lvl2pPr>
            <a:lvl3pPr marL="813633" indent="0">
              <a:buNone/>
              <a:defRPr sz="1068"/>
            </a:lvl3pPr>
            <a:lvl4pPr marL="1220450" indent="0">
              <a:buNone/>
              <a:defRPr sz="890"/>
            </a:lvl4pPr>
            <a:lvl5pPr marL="1627266" indent="0">
              <a:buNone/>
              <a:defRPr sz="890"/>
            </a:lvl5pPr>
            <a:lvl6pPr marL="2034083" indent="0">
              <a:buNone/>
              <a:defRPr sz="890"/>
            </a:lvl6pPr>
            <a:lvl7pPr marL="2440899" indent="0">
              <a:buNone/>
              <a:defRPr sz="890"/>
            </a:lvl7pPr>
            <a:lvl8pPr marL="2847716" indent="0">
              <a:buNone/>
              <a:defRPr sz="890"/>
            </a:lvl8pPr>
            <a:lvl9pPr marL="3254532" indent="0">
              <a:buNone/>
              <a:defRPr sz="89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706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0405" y="768032"/>
            <a:ext cx="2624052" cy="2688114"/>
          </a:xfrm>
        </p:spPr>
        <p:txBody>
          <a:bodyPr anchor="b"/>
          <a:lstStyle>
            <a:lvl1pPr>
              <a:defRPr sz="284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58833" y="1658740"/>
            <a:ext cx="4118819" cy="8187013"/>
          </a:xfrm>
        </p:spPr>
        <p:txBody>
          <a:bodyPr anchor="t"/>
          <a:lstStyle>
            <a:lvl1pPr marL="0" indent="0">
              <a:buNone/>
              <a:defRPr sz="2847"/>
            </a:lvl1pPr>
            <a:lvl2pPr marL="406817" indent="0">
              <a:buNone/>
              <a:defRPr sz="2491"/>
            </a:lvl2pPr>
            <a:lvl3pPr marL="813633" indent="0">
              <a:buNone/>
              <a:defRPr sz="2136"/>
            </a:lvl3pPr>
            <a:lvl4pPr marL="1220450" indent="0">
              <a:buNone/>
              <a:defRPr sz="1780"/>
            </a:lvl4pPr>
            <a:lvl5pPr marL="1627266" indent="0">
              <a:buNone/>
              <a:defRPr sz="1780"/>
            </a:lvl5pPr>
            <a:lvl6pPr marL="2034083" indent="0">
              <a:buNone/>
              <a:defRPr sz="1780"/>
            </a:lvl6pPr>
            <a:lvl7pPr marL="2440899" indent="0">
              <a:buNone/>
              <a:defRPr sz="1780"/>
            </a:lvl7pPr>
            <a:lvl8pPr marL="2847716" indent="0">
              <a:buNone/>
              <a:defRPr sz="1780"/>
            </a:lvl8pPr>
            <a:lvl9pPr marL="3254532" indent="0">
              <a:buNone/>
              <a:defRPr sz="178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0405" y="3456146"/>
            <a:ext cx="2624052" cy="6402939"/>
          </a:xfrm>
        </p:spPr>
        <p:txBody>
          <a:bodyPr/>
          <a:lstStyle>
            <a:lvl1pPr marL="0" indent="0">
              <a:buNone/>
              <a:defRPr sz="1424"/>
            </a:lvl1pPr>
            <a:lvl2pPr marL="406817" indent="0">
              <a:buNone/>
              <a:defRPr sz="1246"/>
            </a:lvl2pPr>
            <a:lvl3pPr marL="813633" indent="0">
              <a:buNone/>
              <a:defRPr sz="1068"/>
            </a:lvl3pPr>
            <a:lvl4pPr marL="1220450" indent="0">
              <a:buNone/>
              <a:defRPr sz="890"/>
            </a:lvl4pPr>
            <a:lvl5pPr marL="1627266" indent="0">
              <a:buNone/>
              <a:defRPr sz="890"/>
            </a:lvl5pPr>
            <a:lvl6pPr marL="2034083" indent="0">
              <a:buNone/>
              <a:defRPr sz="890"/>
            </a:lvl6pPr>
            <a:lvl7pPr marL="2440899" indent="0">
              <a:buNone/>
              <a:defRPr sz="890"/>
            </a:lvl7pPr>
            <a:lvl8pPr marL="2847716" indent="0">
              <a:buNone/>
              <a:defRPr sz="890"/>
            </a:lvl8pPr>
            <a:lvl9pPr marL="3254532" indent="0">
              <a:buNone/>
              <a:defRPr sz="89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3497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59346" y="613362"/>
            <a:ext cx="7017247" cy="2226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59346" y="3066796"/>
            <a:ext cx="7017247" cy="73096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59346" y="10677788"/>
            <a:ext cx="18305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EF94E3-3E99-4D87-8C79-4DA52A3888F2}" type="datetimeFigureOut">
              <a:rPr kumimoji="1" lang="ja-JP" altLang="en-US" smtClean="0"/>
              <a:t>2025/2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95030" y="10677788"/>
            <a:ext cx="2745879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46006" y="10677788"/>
            <a:ext cx="1830586" cy="6133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6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846D73-5B25-4656-9AC0-ECFDA40330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4223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13633" rtl="0" eaLnBrk="1" latinLnBrk="0" hangingPunct="1">
        <a:lnSpc>
          <a:spcPct val="90000"/>
        </a:lnSpc>
        <a:spcBef>
          <a:spcPct val="0"/>
        </a:spcBef>
        <a:buNone/>
        <a:defRPr kumimoji="1" sz="391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3408" indent="-203408" algn="l" defTabSz="813633" rtl="0" eaLnBrk="1" latinLnBrk="0" hangingPunct="1">
        <a:lnSpc>
          <a:spcPct val="90000"/>
        </a:lnSpc>
        <a:spcBef>
          <a:spcPts val="890"/>
        </a:spcBef>
        <a:buFont typeface="Arial" panose="020B0604020202020204" pitchFamily="34" charset="0"/>
        <a:buChar char="•"/>
        <a:defRPr kumimoji="1" sz="2491" kern="1200">
          <a:solidFill>
            <a:schemeClr val="tx1"/>
          </a:solidFill>
          <a:latin typeface="+mn-lt"/>
          <a:ea typeface="+mn-ea"/>
          <a:cs typeface="+mn-cs"/>
        </a:defRPr>
      </a:lvl1pPr>
      <a:lvl2pPr marL="610225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2136" kern="1200">
          <a:solidFill>
            <a:schemeClr val="tx1"/>
          </a:solidFill>
          <a:latin typeface="+mn-lt"/>
          <a:ea typeface="+mn-ea"/>
          <a:cs typeface="+mn-cs"/>
        </a:defRPr>
      </a:lvl2pPr>
      <a:lvl3pPr marL="101704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780" kern="1200">
          <a:solidFill>
            <a:schemeClr val="tx1"/>
          </a:solidFill>
          <a:latin typeface="+mn-lt"/>
          <a:ea typeface="+mn-ea"/>
          <a:cs typeface="+mn-cs"/>
        </a:defRPr>
      </a:lvl3pPr>
      <a:lvl4pPr marL="1423858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4pPr>
      <a:lvl5pPr marL="1830675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5pPr>
      <a:lvl6pPr marL="223749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6pPr>
      <a:lvl7pPr marL="2644308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7pPr>
      <a:lvl8pPr marL="3051124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8pPr>
      <a:lvl9pPr marL="3457941" indent="-203408" algn="l" defTabSz="813633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1pPr>
      <a:lvl2pPr marL="406817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2pPr>
      <a:lvl3pPr marL="813633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3pPr>
      <a:lvl4pPr marL="1220450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4pPr>
      <a:lvl5pPr marL="1627266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5pPr>
      <a:lvl6pPr marL="2034083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6pPr>
      <a:lvl7pPr marL="2440899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7pPr>
      <a:lvl8pPr marL="2847716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8pPr>
      <a:lvl9pPr marL="3254532" algn="l" defTabSz="813633" rtl="0" eaLnBrk="1" latinLnBrk="0" hangingPunct="1">
        <a:defRPr kumimoji="1" sz="1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図 131">
            <a:extLst>
              <a:ext uri="{FF2B5EF4-FFF2-40B4-BE49-F238E27FC236}">
                <a16:creationId xmlns:a16="http://schemas.microsoft.com/office/drawing/2014/main" id="{9A730B92-45EF-4ECD-6EE6-8D3EC543BE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5279" y="5780759"/>
            <a:ext cx="3614104" cy="2350104"/>
          </a:xfrm>
          <a:prstGeom prst="rect">
            <a:avLst/>
          </a:prstGeom>
        </p:spPr>
      </p:pic>
      <p:pic>
        <p:nvPicPr>
          <p:cNvPr id="130" name="図 129">
            <a:extLst>
              <a:ext uri="{FF2B5EF4-FFF2-40B4-BE49-F238E27FC236}">
                <a16:creationId xmlns:a16="http://schemas.microsoft.com/office/drawing/2014/main" id="{22BCB633-DC2F-AE6C-257E-F01077FA6B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971" y="5720888"/>
            <a:ext cx="3782690" cy="2459729"/>
          </a:xfrm>
          <a:prstGeom prst="rect">
            <a:avLst/>
          </a:prstGeom>
        </p:spPr>
      </p:pic>
      <p:pic>
        <p:nvPicPr>
          <p:cNvPr id="126" name="図 125">
            <a:extLst>
              <a:ext uri="{FF2B5EF4-FFF2-40B4-BE49-F238E27FC236}">
                <a16:creationId xmlns:a16="http://schemas.microsoft.com/office/drawing/2014/main" id="{3AA596EB-B448-BB73-8F28-1040C1668D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58296" y="840219"/>
            <a:ext cx="3772928" cy="2326793"/>
          </a:xfrm>
          <a:prstGeom prst="rect">
            <a:avLst/>
          </a:prstGeom>
        </p:spPr>
      </p:pic>
      <p:pic>
        <p:nvPicPr>
          <p:cNvPr id="53" name="図 52">
            <a:extLst>
              <a:ext uri="{FF2B5EF4-FFF2-40B4-BE49-F238E27FC236}">
                <a16:creationId xmlns:a16="http://schemas.microsoft.com/office/drawing/2014/main" id="{99700BC8-8419-BAA0-6976-484E6E4C1F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24963" y="822370"/>
            <a:ext cx="3847574" cy="237282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DAB3AE6-8638-9C8D-2A71-DB73C2C5F4DB}"/>
              </a:ext>
            </a:extLst>
          </p:cNvPr>
          <p:cNvSpPr txBox="1"/>
          <p:nvPr/>
        </p:nvSpPr>
        <p:spPr>
          <a:xfrm>
            <a:off x="48069" y="261930"/>
            <a:ext cx="3069282" cy="374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801" b="1"/>
              <a:t>Supplemental Figure2</a:t>
            </a:r>
            <a:endParaRPr kumimoji="1" lang="ja-JP" altLang="en-US" sz="1801" b="1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5AD30BFC-0E87-17B8-ED86-333BA1910762}"/>
              </a:ext>
            </a:extLst>
          </p:cNvPr>
          <p:cNvSpPr txBox="1"/>
          <p:nvPr/>
        </p:nvSpPr>
        <p:spPr>
          <a:xfrm>
            <a:off x="190475" y="696966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F7AADF1-0F11-C1AE-4A8C-8A0682C77721}"/>
              </a:ext>
            </a:extLst>
          </p:cNvPr>
          <p:cNvSpPr txBox="1"/>
          <p:nvPr/>
        </p:nvSpPr>
        <p:spPr>
          <a:xfrm>
            <a:off x="2621576" y="1413274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E79A1E2-EA28-E007-8C2D-0E5EE486739E}"/>
              </a:ext>
            </a:extLst>
          </p:cNvPr>
          <p:cNvSpPr txBox="1"/>
          <p:nvPr/>
        </p:nvSpPr>
        <p:spPr>
          <a:xfrm>
            <a:off x="2641682" y="1125669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243CA450-D1A8-740E-417B-7852376E6B9E}"/>
              </a:ext>
            </a:extLst>
          </p:cNvPr>
          <p:cNvCxnSpPr>
            <a:cxnSpLocks/>
          </p:cNvCxnSpPr>
          <p:nvPr/>
        </p:nvCxnSpPr>
        <p:spPr>
          <a:xfrm>
            <a:off x="2242469" y="1267746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7AC3A75A-6463-91C8-AC3F-0EFD427C1D21}"/>
              </a:ext>
            </a:extLst>
          </p:cNvPr>
          <p:cNvCxnSpPr>
            <a:cxnSpLocks/>
          </p:cNvCxnSpPr>
          <p:nvPr/>
        </p:nvCxnSpPr>
        <p:spPr>
          <a:xfrm>
            <a:off x="2242810" y="1550110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542BB6C-12D4-14C9-0D36-14AB1ACB4B7B}"/>
              </a:ext>
            </a:extLst>
          </p:cNvPr>
          <p:cNvSpPr txBox="1"/>
          <p:nvPr/>
        </p:nvSpPr>
        <p:spPr>
          <a:xfrm>
            <a:off x="1360604" y="3067148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067059D-700D-AA51-9F9C-FE366E34D755}"/>
              </a:ext>
            </a:extLst>
          </p:cNvPr>
          <p:cNvSpPr txBox="1"/>
          <p:nvPr/>
        </p:nvSpPr>
        <p:spPr>
          <a:xfrm>
            <a:off x="1359395" y="3415243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533D27C-3D68-B294-565A-86CA18FB76E4}"/>
              </a:ext>
            </a:extLst>
          </p:cNvPr>
          <p:cNvSpPr txBox="1"/>
          <p:nvPr/>
        </p:nvSpPr>
        <p:spPr>
          <a:xfrm>
            <a:off x="1959607" y="3067148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4812C43-A853-AD61-8C46-7DC121C2BD9E}"/>
              </a:ext>
            </a:extLst>
          </p:cNvPr>
          <p:cNvSpPr txBox="1"/>
          <p:nvPr/>
        </p:nvSpPr>
        <p:spPr>
          <a:xfrm>
            <a:off x="2524071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D8E6924-C855-FF9E-9F19-2B1668247E34}"/>
              </a:ext>
            </a:extLst>
          </p:cNvPr>
          <p:cNvSpPr txBox="1"/>
          <p:nvPr/>
        </p:nvSpPr>
        <p:spPr>
          <a:xfrm>
            <a:off x="3087045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F412DE-9B3B-B88C-509F-6E97CEB61B61}"/>
              </a:ext>
            </a:extLst>
          </p:cNvPr>
          <p:cNvSpPr txBox="1"/>
          <p:nvPr/>
        </p:nvSpPr>
        <p:spPr>
          <a:xfrm>
            <a:off x="3612984" y="3058834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5340785-FAD4-E3BF-9930-1B8E4C1B311A}"/>
              </a:ext>
            </a:extLst>
          </p:cNvPr>
          <p:cNvSpPr txBox="1"/>
          <p:nvPr/>
        </p:nvSpPr>
        <p:spPr>
          <a:xfrm>
            <a:off x="1962665" y="3415244"/>
            <a:ext cx="380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00805FA-928E-205E-663B-DCB8BFA54042}"/>
              </a:ext>
            </a:extLst>
          </p:cNvPr>
          <p:cNvSpPr txBox="1"/>
          <p:nvPr/>
        </p:nvSpPr>
        <p:spPr>
          <a:xfrm>
            <a:off x="2534842" y="3415244"/>
            <a:ext cx="4498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6C76B29-5FE7-BDDD-140D-7E7A9DD9C4E1}"/>
              </a:ext>
            </a:extLst>
          </p:cNvPr>
          <p:cNvSpPr txBox="1"/>
          <p:nvPr/>
        </p:nvSpPr>
        <p:spPr>
          <a:xfrm>
            <a:off x="3085088" y="3415244"/>
            <a:ext cx="45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8EF194DC-1052-C386-18D8-13A368617B96}"/>
              </a:ext>
            </a:extLst>
          </p:cNvPr>
          <p:cNvSpPr txBox="1"/>
          <p:nvPr/>
        </p:nvSpPr>
        <p:spPr>
          <a:xfrm>
            <a:off x="3612984" y="3415243"/>
            <a:ext cx="359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5EF8750-B237-5E09-5A94-5AB89D4CD04E}"/>
              </a:ext>
            </a:extLst>
          </p:cNvPr>
          <p:cNvSpPr txBox="1"/>
          <p:nvPr/>
        </p:nvSpPr>
        <p:spPr>
          <a:xfrm>
            <a:off x="76321" y="2770799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EFB9282-6448-8C11-FF3A-30D09D785124}"/>
              </a:ext>
            </a:extLst>
          </p:cNvPr>
          <p:cNvSpPr txBox="1"/>
          <p:nvPr/>
        </p:nvSpPr>
        <p:spPr>
          <a:xfrm>
            <a:off x="883061" y="3066362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F578F07-6296-CF7C-CFDE-7E73397A0106}"/>
              </a:ext>
            </a:extLst>
          </p:cNvPr>
          <p:cNvSpPr txBox="1"/>
          <p:nvPr/>
        </p:nvSpPr>
        <p:spPr>
          <a:xfrm>
            <a:off x="5288550" y="3067148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98D645D-EEA1-A6B4-2DD8-FA9840BE74BC}"/>
              </a:ext>
            </a:extLst>
          </p:cNvPr>
          <p:cNvSpPr txBox="1"/>
          <p:nvPr/>
        </p:nvSpPr>
        <p:spPr>
          <a:xfrm>
            <a:off x="5287340" y="3415243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4E7268A-B020-87F7-1EF2-2F179C18778D}"/>
              </a:ext>
            </a:extLst>
          </p:cNvPr>
          <p:cNvSpPr txBox="1"/>
          <p:nvPr/>
        </p:nvSpPr>
        <p:spPr>
          <a:xfrm>
            <a:off x="5861110" y="3067148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0AF1AB6-6FF9-DDAE-1AB8-E7D4D9A8A0D5}"/>
              </a:ext>
            </a:extLst>
          </p:cNvPr>
          <p:cNvSpPr txBox="1"/>
          <p:nvPr/>
        </p:nvSpPr>
        <p:spPr>
          <a:xfrm>
            <a:off x="6404305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6859A33-CE09-A50B-BF2D-BF5E6726F797}"/>
              </a:ext>
            </a:extLst>
          </p:cNvPr>
          <p:cNvSpPr txBox="1"/>
          <p:nvPr/>
        </p:nvSpPr>
        <p:spPr>
          <a:xfrm>
            <a:off x="6948727" y="3067147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4EA7CDDE-EA66-4400-E155-3FADB568C08D}"/>
              </a:ext>
            </a:extLst>
          </p:cNvPr>
          <p:cNvSpPr txBox="1"/>
          <p:nvPr/>
        </p:nvSpPr>
        <p:spPr>
          <a:xfrm>
            <a:off x="7506538" y="3058834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F726792-6EED-6347-A311-FF6ABD8566B3}"/>
              </a:ext>
            </a:extLst>
          </p:cNvPr>
          <p:cNvSpPr txBox="1"/>
          <p:nvPr/>
        </p:nvSpPr>
        <p:spPr>
          <a:xfrm>
            <a:off x="5865032" y="3415244"/>
            <a:ext cx="4083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0B774B3B-B16C-7A9E-20C5-E925D1EEA160}"/>
              </a:ext>
            </a:extLst>
          </p:cNvPr>
          <p:cNvSpPr txBox="1"/>
          <p:nvPr/>
        </p:nvSpPr>
        <p:spPr>
          <a:xfrm>
            <a:off x="6407125" y="3415244"/>
            <a:ext cx="44989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91B0F222-C348-AEA5-7B25-690FD3F0214A}"/>
              </a:ext>
            </a:extLst>
          </p:cNvPr>
          <p:cNvSpPr txBox="1"/>
          <p:nvPr/>
        </p:nvSpPr>
        <p:spPr>
          <a:xfrm>
            <a:off x="6955585" y="3415244"/>
            <a:ext cx="45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8BB44A87-344F-3585-4D9F-3BE9EE7E0C66}"/>
              </a:ext>
            </a:extLst>
          </p:cNvPr>
          <p:cNvSpPr txBox="1"/>
          <p:nvPr/>
        </p:nvSpPr>
        <p:spPr>
          <a:xfrm>
            <a:off x="7501236" y="3415243"/>
            <a:ext cx="359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35B6E22-CAE7-CF82-29E2-EB6B539DAB08}"/>
              </a:ext>
            </a:extLst>
          </p:cNvPr>
          <p:cNvSpPr txBox="1"/>
          <p:nvPr/>
        </p:nvSpPr>
        <p:spPr>
          <a:xfrm>
            <a:off x="4044952" y="2770799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67AC0ED-23A1-5306-2ED1-A099DD255C2E}"/>
              </a:ext>
            </a:extLst>
          </p:cNvPr>
          <p:cNvSpPr txBox="1"/>
          <p:nvPr/>
        </p:nvSpPr>
        <p:spPr>
          <a:xfrm>
            <a:off x="14583" y="3409041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2FF4E4D-8C0C-1DDD-DCE3-A7DA641EA82C}"/>
              </a:ext>
            </a:extLst>
          </p:cNvPr>
          <p:cNvSpPr txBox="1"/>
          <p:nvPr/>
        </p:nvSpPr>
        <p:spPr>
          <a:xfrm>
            <a:off x="1269661" y="3655999"/>
            <a:ext cx="1847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PF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4E207C80-1F08-E516-A7BA-115FA388E70C}"/>
              </a:ext>
            </a:extLst>
          </p:cNvPr>
          <p:cNvSpPr txBox="1"/>
          <p:nvPr/>
        </p:nvSpPr>
        <p:spPr>
          <a:xfrm>
            <a:off x="4401077" y="3656002"/>
            <a:ext cx="3772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LPFS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3453CABF-58E1-718C-42A5-1C345EEEE3DA}"/>
              </a:ext>
            </a:extLst>
          </p:cNvPr>
          <p:cNvSpPr txBox="1"/>
          <p:nvPr/>
        </p:nvSpPr>
        <p:spPr>
          <a:xfrm>
            <a:off x="4013734" y="690341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5026735-E59E-DC7A-7F99-938F10496544}"/>
              </a:ext>
            </a:extLst>
          </p:cNvPr>
          <p:cNvSpPr txBox="1"/>
          <p:nvPr/>
        </p:nvSpPr>
        <p:spPr>
          <a:xfrm>
            <a:off x="1306279" y="8212372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3C03BE7-2D44-6EE0-C50F-9BA75138EFE4}"/>
              </a:ext>
            </a:extLst>
          </p:cNvPr>
          <p:cNvSpPr txBox="1"/>
          <p:nvPr/>
        </p:nvSpPr>
        <p:spPr>
          <a:xfrm>
            <a:off x="1823301" y="8212371"/>
            <a:ext cx="281884" cy="2690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D27DB2E1-04ED-49BD-8B83-635D3759159D}"/>
              </a:ext>
            </a:extLst>
          </p:cNvPr>
          <p:cNvSpPr txBox="1"/>
          <p:nvPr/>
        </p:nvSpPr>
        <p:spPr>
          <a:xfrm>
            <a:off x="2295868" y="8212371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55827A4D-47FB-DF6A-C92F-53B08EE0B9C2}"/>
              </a:ext>
            </a:extLst>
          </p:cNvPr>
          <p:cNvSpPr txBox="1"/>
          <p:nvPr/>
        </p:nvSpPr>
        <p:spPr>
          <a:xfrm>
            <a:off x="3270519" y="8204420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A873007-C73B-334D-A251-FC944FE32441}"/>
              </a:ext>
            </a:extLst>
          </p:cNvPr>
          <p:cNvSpPr txBox="1"/>
          <p:nvPr/>
        </p:nvSpPr>
        <p:spPr>
          <a:xfrm>
            <a:off x="3742589" y="8204058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18DEE868-3704-8C68-094B-F7E442C7B74F}"/>
              </a:ext>
            </a:extLst>
          </p:cNvPr>
          <p:cNvSpPr txBox="1"/>
          <p:nvPr/>
        </p:nvSpPr>
        <p:spPr>
          <a:xfrm>
            <a:off x="65452" y="7916023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C5532557-4143-5102-FC32-55A77ECDC4E7}"/>
              </a:ext>
            </a:extLst>
          </p:cNvPr>
          <p:cNvSpPr txBox="1"/>
          <p:nvPr/>
        </p:nvSpPr>
        <p:spPr>
          <a:xfrm>
            <a:off x="4119383" y="7916023"/>
            <a:ext cx="15207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Number at risk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46189D9-4F38-7386-8FBA-8B0CB44F29D0}"/>
              </a:ext>
            </a:extLst>
          </p:cNvPr>
          <p:cNvSpPr txBox="1"/>
          <p:nvPr/>
        </p:nvSpPr>
        <p:spPr>
          <a:xfrm>
            <a:off x="2793210" y="8212711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2C28285-98EF-8D58-33CC-06EB970D5123}"/>
              </a:ext>
            </a:extLst>
          </p:cNvPr>
          <p:cNvSpPr txBox="1"/>
          <p:nvPr/>
        </p:nvSpPr>
        <p:spPr>
          <a:xfrm>
            <a:off x="1300516" y="8563557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0E4415D7-FDAA-0CAA-9D2E-B5FEF4EA97AD}"/>
              </a:ext>
            </a:extLst>
          </p:cNvPr>
          <p:cNvSpPr txBox="1"/>
          <p:nvPr/>
        </p:nvSpPr>
        <p:spPr>
          <a:xfrm>
            <a:off x="1782101" y="8563557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6A6A6B6C-26B1-4E9E-78C6-D5CF815CCA64}"/>
              </a:ext>
            </a:extLst>
          </p:cNvPr>
          <p:cNvSpPr txBox="1"/>
          <p:nvPr/>
        </p:nvSpPr>
        <p:spPr>
          <a:xfrm>
            <a:off x="2261753" y="8563556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6B96D6F-3322-8357-33C4-03E14E66545D}"/>
              </a:ext>
            </a:extLst>
          </p:cNvPr>
          <p:cNvSpPr txBox="1"/>
          <p:nvPr/>
        </p:nvSpPr>
        <p:spPr>
          <a:xfrm>
            <a:off x="3271845" y="8555605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BE55F7E-A55B-58FC-7EAF-3CEF1E423E5F}"/>
              </a:ext>
            </a:extLst>
          </p:cNvPr>
          <p:cNvSpPr txBox="1"/>
          <p:nvPr/>
        </p:nvSpPr>
        <p:spPr>
          <a:xfrm>
            <a:off x="3751003" y="8555243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4A13544-CF40-1215-F6B1-B7833FF0EB3E}"/>
              </a:ext>
            </a:extLst>
          </p:cNvPr>
          <p:cNvSpPr txBox="1"/>
          <p:nvPr/>
        </p:nvSpPr>
        <p:spPr>
          <a:xfrm>
            <a:off x="2794831" y="8563033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C79933B1-1A03-43A4-C486-27C5E5A08320}"/>
              </a:ext>
            </a:extLst>
          </p:cNvPr>
          <p:cNvSpPr txBox="1"/>
          <p:nvPr/>
        </p:nvSpPr>
        <p:spPr>
          <a:xfrm>
            <a:off x="5273300" y="8564884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6BCC4C75-E11D-13E0-A504-63E9DD37852C}"/>
              </a:ext>
            </a:extLst>
          </p:cNvPr>
          <p:cNvSpPr txBox="1"/>
          <p:nvPr/>
        </p:nvSpPr>
        <p:spPr>
          <a:xfrm>
            <a:off x="5709944" y="8564884"/>
            <a:ext cx="571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1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DDF65586-60E2-B5AE-81A5-2816A819305A}"/>
              </a:ext>
            </a:extLst>
          </p:cNvPr>
          <p:cNvSpPr txBox="1"/>
          <p:nvPr/>
        </p:nvSpPr>
        <p:spPr>
          <a:xfrm>
            <a:off x="6193617" y="8564883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904588E-725F-5738-7AA6-442B13A4F5A6}"/>
              </a:ext>
            </a:extLst>
          </p:cNvPr>
          <p:cNvSpPr txBox="1"/>
          <p:nvPr/>
        </p:nvSpPr>
        <p:spPr>
          <a:xfrm>
            <a:off x="7121658" y="8564883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53BEF817-C73A-400C-AADF-B200DB4885D7}"/>
              </a:ext>
            </a:extLst>
          </p:cNvPr>
          <p:cNvSpPr txBox="1"/>
          <p:nvPr/>
        </p:nvSpPr>
        <p:spPr>
          <a:xfrm>
            <a:off x="7591940" y="8572472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E37C4399-9C5C-13CE-3B02-1330B9A56426}"/>
              </a:ext>
            </a:extLst>
          </p:cNvPr>
          <p:cNvSpPr txBox="1"/>
          <p:nvPr/>
        </p:nvSpPr>
        <p:spPr>
          <a:xfrm>
            <a:off x="6646937" y="8564360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CF351350-64F3-4206-194B-FA79749ED9EC}"/>
              </a:ext>
            </a:extLst>
          </p:cNvPr>
          <p:cNvSpPr txBox="1"/>
          <p:nvPr/>
        </p:nvSpPr>
        <p:spPr>
          <a:xfrm>
            <a:off x="5271978" y="8213698"/>
            <a:ext cx="5445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77EE8E0-9F7C-C2B2-A9F9-931566886457}"/>
              </a:ext>
            </a:extLst>
          </p:cNvPr>
          <p:cNvSpPr txBox="1"/>
          <p:nvPr/>
        </p:nvSpPr>
        <p:spPr>
          <a:xfrm>
            <a:off x="5737837" y="8213698"/>
            <a:ext cx="250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19754358-BAC8-3462-5BF8-D5EAFCD30509}"/>
              </a:ext>
            </a:extLst>
          </p:cNvPr>
          <p:cNvSpPr txBox="1"/>
          <p:nvPr/>
        </p:nvSpPr>
        <p:spPr>
          <a:xfrm>
            <a:off x="6191605" y="8213697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CF7D5EDE-C988-1A42-4585-AB2BB4A67A36}"/>
              </a:ext>
            </a:extLst>
          </p:cNvPr>
          <p:cNvSpPr txBox="1"/>
          <p:nvPr/>
        </p:nvSpPr>
        <p:spPr>
          <a:xfrm>
            <a:off x="7120336" y="8205746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6AF6E577-ACB6-31BB-5C0D-487699B8B9A8}"/>
              </a:ext>
            </a:extLst>
          </p:cNvPr>
          <p:cNvSpPr txBox="1"/>
          <p:nvPr/>
        </p:nvSpPr>
        <p:spPr>
          <a:xfrm>
            <a:off x="7584393" y="8205384"/>
            <a:ext cx="2884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0DA24F76-7191-EC84-49E6-4912FB1EBCC5}"/>
              </a:ext>
            </a:extLst>
          </p:cNvPr>
          <p:cNvSpPr txBox="1"/>
          <p:nvPr/>
        </p:nvSpPr>
        <p:spPr>
          <a:xfrm>
            <a:off x="6645615" y="8213174"/>
            <a:ext cx="404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ja-JP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63E259D-5DCD-4F73-6B3D-D98780E6C19A}"/>
              </a:ext>
            </a:extLst>
          </p:cNvPr>
          <p:cNvSpPr txBox="1"/>
          <p:nvPr/>
        </p:nvSpPr>
        <p:spPr>
          <a:xfrm>
            <a:off x="1263036" y="8817728"/>
            <a:ext cx="184769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OS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F3700C33-AA60-E042-B8AE-D1011673C461}"/>
              </a:ext>
            </a:extLst>
          </p:cNvPr>
          <p:cNvSpPr txBox="1"/>
          <p:nvPr/>
        </p:nvSpPr>
        <p:spPr>
          <a:xfrm>
            <a:off x="4394452" y="8817731"/>
            <a:ext cx="3772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OP-OS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DB903FA-64E4-5D6F-A463-83928ED09C71}"/>
              </a:ext>
            </a:extLst>
          </p:cNvPr>
          <p:cNvSpPr txBox="1"/>
          <p:nvPr/>
        </p:nvSpPr>
        <p:spPr>
          <a:xfrm>
            <a:off x="183851" y="5553900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97903B8-CF8B-353F-4664-0A61B47A9BE6}"/>
              </a:ext>
            </a:extLst>
          </p:cNvPr>
          <p:cNvSpPr txBox="1"/>
          <p:nvPr/>
        </p:nvSpPr>
        <p:spPr>
          <a:xfrm>
            <a:off x="4007110" y="5547275"/>
            <a:ext cx="5115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8E1E10C7-A8CF-2CDC-8243-68EFFBD29D0C}"/>
              </a:ext>
            </a:extLst>
          </p:cNvPr>
          <p:cNvSpPr txBox="1"/>
          <p:nvPr/>
        </p:nvSpPr>
        <p:spPr>
          <a:xfrm>
            <a:off x="4792305" y="3062820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B1E6ACE0-1F01-3408-E4AB-7EBC4FACF18A}"/>
              </a:ext>
            </a:extLst>
          </p:cNvPr>
          <p:cNvSpPr txBox="1"/>
          <p:nvPr/>
        </p:nvSpPr>
        <p:spPr>
          <a:xfrm>
            <a:off x="3923827" y="3398411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6071892D-DD3C-08DD-01D9-6EB448B7170D}"/>
              </a:ext>
            </a:extLst>
          </p:cNvPr>
          <p:cNvSpPr txBox="1"/>
          <p:nvPr/>
        </p:nvSpPr>
        <p:spPr>
          <a:xfrm>
            <a:off x="844082" y="8208991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F49F4B0-370E-8371-93D3-7E3A6932069B}"/>
              </a:ext>
            </a:extLst>
          </p:cNvPr>
          <p:cNvSpPr txBox="1"/>
          <p:nvPr/>
        </p:nvSpPr>
        <p:spPr>
          <a:xfrm>
            <a:off x="-31484" y="8551670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CB6AC9BB-85AE-2FA1-9729-A313E607B459}"/>
              </a:ext>
            </a:extLst>
          </p:cNvPr>
          <p:cNvSpPr txBox="1"/>
          <p:nvPr/>
        </p:nvSpPr>
        <p:spPr>
          <a:xfrm>
            <a:off x="4824202" y="8212539"/>
            <a:ext cx="598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3F77C268-FA6A-122A-0016-AEF7FC4DC6AF}"/>
              </a:ext>
            </a:extLst>
          </p:cNvPr>
          <p:cNvSpPr txBox="1"/>
          <p:nvPr/>
        </p:nvSpPr>
        <p:spPr>
          <a:xfrm>
            <a:off x="3955724" y="8555218"/>
            <a:ext cx="13970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u="sng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lang="ja-JP" altLang="en-US" sz="11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B1DA434-F991-FC51-91D3-5C2C3B2E4574}"/>
              </a:ext>
            </a:extLst>
          </p:cNvPr>
          <p:cNvSpPr txBox="1"/>
          <p:nvPr/>
        </p:nvSpPr>
        <p:spPr>
          <a:xfrm>
            <a:off x="6524151" y="1409417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B41B163-6A95-B3CC-0B1F-E9B1E103A255}"/>
              </a:ext>
            </a:extLst>
          </p:cNvPr>
          <p:cNvSpPr txBox="1"/>
          <p:nvPr/>
        </p:nvSpPr>
        <p:spPr>
          <a:xfrm>
            <a:off x="6544257" y="1121812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2AB2DEE5-E054-2902-30C3-617433F1CDB2}"/>
              </a:ext>
            </a:extLst>
          </p:cNvPr>
          <p:cNvCxnSpPr>
            <a:cxnSpLocks/>
          </p:cNvCxnSpPr>
          <p:nvPr/>
        </p:nvCxnSpPr>
        <p:spPr>
          <a:xfrm>
            <a:off x="6145044" y="1263889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C49C7D23-E7F1-C53C-5151-17DA25ED6AF7}"/>
              </a:ext>
            </a:extLst>
          </p:cNvPr>
          <p:cNvCxnSpPr>
            <a:cxnSpLocks/>
          </p:cNvCxnSpPr>
          <p:nvPr/>
        </p:nvCxnSpPr>
        <p:spPr>
          <a:xfrm>
            <a:off x="6145385" y="1546253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F3E9CF6-747D-8233-E1F8-48EA3B8267EB}"/>
              </a:ext>
            </a:extLst>
          </p:cNvPr>
          <p:cNvSpPr txBox="1"/>
          <p:nvPr/>
        </p:nvSpPr>
        <p:spPr>
          <a:xfrm>
            <a:off x="2618035" y="6137687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97140B0-B323-D154-BB98-432791D6D3ED}"/>
              </a:ext>
            </a:extLst>
          </p:cNvPr>
          <p:cNvSpPr txBox="1"/>
          <p:nvPr/>
        </p:nvSpPr>
        <p:spPr>
          <a:xfrm>
            <a:off x="2638141" y="5850082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34C072AB-B3C6-4C2C-0C28-14C8BE3BEBAD}"/>
              </a:ext>
            </a:extLst>
          </p:cNvPr>
          <p:cNvCxnSpPr>
            <a:cxnSpLocks/>
          </p:cNvCxnSpPr>
          <p:nvPr/>
        </p:nvCxnSpPr>
        <p:spPr>
          <a:xfrm>
            <a:off x="2238928" y="5992159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コネクタ 47">
            <a:extLst>
              <a:ext uri="{FF2B5EF4-FFF2-40B4-BE49-F238E27FC236}">
                <a16:creationId xmlns:a16="http://schemas.microsoft.com/office/drawing/2014/main" id="{CECCC0EA-CD56-CD10-F6BA-93F02DB9187E}"/>
              </a:ext>
            </a:extLst>
          </p:cNvPr>
          <p:cNvCxnSpPr>
            <a:cxnSpLocks/>
          </p:cNvCxnSpPr>
          <p:nvPr/>
        </p:nvCxnSpPr>
        <p:spPr>
          <a:xfrm>
            <a:off x="2239269" y="6274523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BF83EC0-58E5-D9F7-59C2-C4E51D1AA31D}"/>
              </a:ext>
            </a:extLst>
          </p:cNvPr>
          <p:cNvSpPr txBox="1"/>
          <p:nvPr/>
        </p:nvSpPr>
        <p:spPr>
          <a:xfrm>
            <a:off x="6459936" y="6137679"/>
            <a:ext cx="15207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ystemic therap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DD9263E1-139F-2629-FDE7-55118D480196}"/>
              </a:ext>
            </a:extLst>
          </p:cNvPr>
          <p:cNvSpPr txBox="1"/>
          <p:nvPr/>
        </p:nvSpPr>
        <p:spPr>
          <a:xfrm>
            <a:off x="6480042" y="5850074"/>
            <a:ext cx="7480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LAT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65A12894-78CD-EA4C-92E2-1EAF82856434}"/>
              </a:ext>
            </a:extLst>
          </p:cNvPr>
          <p:cNvCxnSpPr>
            <a:cxnSpLocks/>
          </p:cNvCxnSpPr>
          <p:nvPr/>
        </p:nvCxnSpPr>
        <p:spPr>
          <a:xfrm>
            <a:off x="6080829" y="5992151"/>
            <a:ext cx="37760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AA80BC76-7D77-1EF7-F5C2-8951A856B96E}"/>
              </a:ext>
            </a:extLst>
          </p:cNvPr>
          <p:cNvCxnSpPr>
            <a:cxnSpLocks/>
          </p:cNvCxnSpPr>
          <p:nvPr/>
        </p:nvCxnSpPr>
        <p:spPr>
          <a:xfrm>
            <a:off x="6081170" y="6274515"/>
            <a:ext cx="37760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E4ED72A4-EB9C-4049-B85E-2F7AC458A3F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45327533"/>
              </p:ext>
            </p:extLst>
          </p:nvPr>
        </p:nvGraphicFramePr>
        <p:xfrm>
          <a:off x="218104" y="3999724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PF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–8.5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1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.5–14.2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 (0.52-2.42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B7FBCE81-00DB-6B80-D75A-07E8593D48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5260725"/>
              </p:ext>
            </p:extLst>
          </p:nvPr>
        </p:nvGraphicFramePr>
        <p:xfrm>
          <a:off x="4251121" y="3996007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LPF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–8.9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1–8.9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7 (0.49-2.32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6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33" name="表 32">
            <a:extLst>
              <a:ext uri="{FF2B5EF4-FFF2-40B4-BE49-F238E27FC236}">
                <a16:creationId xmlns:a16="http://schemas.microsoft.com/office/drawing/2014/main" id="{2E3E0566-5259-1804-C242-0167833B59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2372106"/>
              </p:ext>
            </p:extLst>
          </p:nvPr>
        </p:nvGraphicFramePr>
        <p:xfrm>
          <a:off x="230989" y="9159479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.7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6.1–55.1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.6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4.7–NR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 (0.38-2.70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  <p:graphicFrame>
        <p:nvGraphicFramePr>
          <p:cNvPr id="34" name="表 33">
            <a:extLst>
              <a:ext uri="{FF2B5EF4-FFF2-40B4-BE49-F238E27FC236}">
                <a16:creationId xmlns:a16="http://schemas.microsoft.com/office/drawing/2014/main" id="{60AA83E5-7946-1615-FDE5-8BB7FF66A8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1758251"/>
              </p:ext>
            </p:extLst>
          </p:nvPr>
        </p:nvGraphicFramePr>
        <p:xfrm>
          <a:off x="4241705" y="9155763"/>
          <a:ext cx="3734439" cy="1225309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67115">
                  <a:extLst>
                    <a:ext uri="{9D8B030D-6E8A-4147-A177-3AD203B41FA5}">
                      <a16:colId xmlns:a16="http://schemas.microsoft.com/office/drawing/2014/main" val="1375256391"/>
                    </a:ext>
                  </a:extLst>
                </a:gridCol>
                <a:gridCol w="1392150">
                  <a:extLst>
                    <a:ext uri="{9D8B030D-6E8A-4147-A177-3AD203B41FA5}">
                      <a16:colId xmlns:a16="http://schemas.microsoft.com/office/drawing/2014/main" val="4187723446"/>
                    </a:ext>
                  </a:extLst>
                </a:gridCol>
                <a:gridCol w="975174">
                  <a:extLst>
                    <a:ext uri="{9D8B030D-6E8A-4147-A177-3AD203B41FA5}">
                      <a16:colId xmlns:a16="http://schemas.microsoft.com/office/drawing/2014/main" val="1944230773"/>
                    </a:ext>
                  </a:extLst>
                </a:gridCol>
              </a:tblGrid>
              <a:tr h="274562">
                <a:tc>
                  <a:txBody>
                    <a:bodyPr/>
                    <a:lstStyle/>
                    <a:p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ystemic therap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6686792"/>
                  </a:ext>
                </a:extLst>
              </a:tr>
              <a:tr h="344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an OP-OS, 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nths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3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5.6–42.4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8</a:t>
                      </a:r>
                    </a:p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6.5–NR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50245"/>
                  </a:ext>
                </a:extLst>
              </a:tr>
              <a:tr h="264947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 (95% CI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 (0.38-2.75)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5889025"/>
                  </a:ext>
                </a:extLst>
              </a:tr>
              <a:tr h="2336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7</a:t>
                      </a:r>
                      <a:endParaRPr kumimoji="1" lang="ja-JP" alt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43762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517765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50</TotalTime>
  <Words>230</Words>
  <Application>Microsoft Office PowerPoint</Application>
  <PresentationFormat>ユーザー設定</PresentationFormat>
  <Paragraphs>1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大亮 森永</dc:creator>
  <cp:lastModifiedBy>大亮 森永</cp:lastModifiedBy>
  <cp:revision>56</cp:revision>
  <dcterms:created xsi:type="dcterms:W3CDTF">2024-11-25T14:27:02Z</dcterms:created>
  <dcterms:modified xsi:type="dcterms:W3CDTF">2025-02-25T04:11:04Z</dcterms:modified>
</cp:coreProperties>
</file>